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444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3439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335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8943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2302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8647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0102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4161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0087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235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9737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992E83-31EF-4F94-B864-7F9F281AE191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59C76-72D6-4275-995F-E033B4868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1258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6652" y="662181"/>
            <a:ext cx="10058400" cy="307086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4770407" y="4307443"/>
            <a:ext cx="22331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4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68919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2464" y="627267"/>
            <a:ext cx="4152900" cy="4152900"/>
          </a:xfrm>
        </p:spPr>
      </p:pic>
      <p:sp>
        <p:nvSpPr>
          <p:cNvPr id="9" name="矩形 8"/>
          <p:cNvSpPr/>
          <p:nvPr/>
        </p:nvSpPr>
        <p:spPr>
          <a:xfrm>
            <a:off x="4687711" y="5360517"/>
            <a:ext cx="28214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-4d-0m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515329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9607" y="541844"/>
            <a:ext cx="4152900" cy="41275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0414" y="541844"/>
            <a:ext cx="4140200" cy="403860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7016808" y="5053821"/>
            <a:ext cx="29384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-4d-</a:t>
            </a:r>
            <a:r>
              <a:rPr lang="en-US" altLang="zh-CN" dirty="0" smtClean="0"/>
              <a:t>12</a:t>
            </a:r>
            <a:r>
              <a:rPr lang="zh-CN" altLang="en-US" dirty="0" smtClean="0"/>
              <a:t>min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2251265" y="4869155"/>
            <a:ext cx="28214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-4d-</a:t>
            </a:r>
            <a:r>
              <a:rPr lang="en-US" altLang="zh-CN" dirty="0" smtClean="0"/>
              <a:t>6</a:t>
            </a:r>
            <a:r>
              <a:rPr lang="zh-CN" altLang="en-US" dirty="0" smtClean="0"/>
              <a:t>m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715423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1942" y="428550"/>
            <a:ext cx="4127500" cy="41529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7579" y="453950"/>
            <a:ext cx="4102100" cy="412750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7814088" y="4898963"/>
            <a:ext cx="29384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-4d-30min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2249311" y="4825208"/>
            <a:ext cx="29384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-4d-</a:t>
            </a:r>
            <a:r>
              <a:rPr lang="en-US" altLang="zh-CN" dirty="0" smtClean="0"/>
              <a:t>18</a:t>
            </a:r>
            <a:r>
              <a:rPr lang="zh-CN" altLang="en-US" dirty="0" smtClean="0"/>
              <a:t>m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877956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116" y="562714"/>
            <a:ext cx="3671751" cy="3426968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9584" y="614704"/>
            <a:ext cx="3671751" cy="342325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14052" y="548559"/>
            <a:ext cx="3660624" cy="3426967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1020618" y="4402574"/>
            <a:ext cx="26788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-4d-Ctrl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5244275" y="4287542"/>
            <a:ext cx="27301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-4d-</a:t>
            </a:r>
            <a:r>
              <a:rPr lang="en-US" altLang="zh-CN" dirty="0" smtClean="0"/>
              <a:t>NGs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8904959" y="4217908"/>
            <a:ext cx="29593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-4d-</a:t>
            </a:r>
            <a:r>
              <a:rPr lang="en-US" altLang="zh-CN" smtClean="0"/>
              <a:t>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44423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3</Words>
  <Application>Microsoft Office PowerPoint</Application>
  <PresentationFormat>宽屏</PresentationFormat>
  <Paragraphs>9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霞</dc:creator>
  <cp:lastModifiedBy>王 霞</cp:lastModifiedBy>
  <cp:revision>1</cp:revision>
  <dcterms:created xsi:type="dcterms:W3CDTF">2018-11-11T13:55:25Z</dcterms:created>
  <dcterms:modified xsi:type="dcterms:W3CDTF">2018-11-11T13:58:45Z</dcterms:modified>
</cp:coreProperties>
</file>